
<file path=[Content_Types].xml><?xml version="1.0" encoding="utf-8"?>
<Types xmlns="http://schemas.openxmlformats.org/package/2006/content-types">
  <Default ContentType="image/jpeg" Extension="jpg"/>
  <Default ContentType="application/x-fontdata" Extension="fntdata"/>
  <Default ContentType="application/xml" Extension="xml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binary" PartName="/ppt/metadata"/>
  <Override ContentType="application/vnd.openxmlformats-officedocument.presentationml.slide+xml" PartName="/ppt/slides/slide1.xml"/>
  <Override ContentType="application/vnd.openxmlformats-officedocument.presentationml.notesMaster+xml" PartName="/ppt/notesMasters/notesMaster1.xml"/>
  <Override ContentType="application/vnd.openxmlformats-package.core-properties+xml" PartName="/docProps/core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</Types>
</file>

<file path=_rels/.rels><?xml version="1.0" encoding="UTF-8" standalone="yes"?>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embedTrueTypeFonts="1" strictFirstAndLastChars="0" saveSubsetFonts="1">
  <p:sldMasterIdLst>
    <p:sldMasterId id="2147483648" r:id="rId3"/>
  </p:sldMasterIdLst>
  <p:notesMasterIdLst>
    <p:notesMasterId r:id="rId4"/>
  </p:notesMasterIdLst>
  <p:sldIdLst>
    <p:sldId id="256" r:id="rId5"/>
  </p:sldIdLst>
  <p:sldSz cy="6858000" cx="12192000"/>
  <p:notesSz cx="6858000" cy="9144000"/>
  <p:embeddedFontLst>
    <p:embeddedFont>
      <p:font typeface="Play"/>
      <p:regular r:id="rId6"/>
      <p:bold r:id="rId7"/>
    </p:embeddedFont>
  </p:embeddedFontLst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GoogleSlidesCustomDataVersion2">
      <go:slidesCustomData xmlns:go="http://customooxmlschemas.google.com/" r:id="rId8" roundtripDataSignature="AMtx7mhMHED1J8ShwGQtHn9KPoO2Op0J5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presProps" Target="presProps.xml"/><Relationship Id="rId3" Type="http://schemas.openxmlformats.org/officeDocument/2006/relationships/slideMaster" Target="slideMasters/slideMaster1.xml"/><Relationship Id="rId4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6" Type="http://schemas.openxmlformats.org/officeDocument/2006/relationships/font" Target="fonts/Play-regular.fntdata"/><Relationship Id="rId7" Type="http://schemas.openxmlformats.org/officeDocument/2006/relationships/font" Target="fonts/Play-bold.fntdata"/><Relationship Id="rId8" Type="http://customschemas.google.com/relationships/presentationmetadata" Target="metadata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0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82" name="Google Shape;82;p1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1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3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3" name="Google Shape;13;p3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4" name="Google Shape;14;p3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Vertical Text" type="vertTx">
  <p:cSld name="VERTICAL_TEXT">
    <p:spTree>
      <p:nvGrpSpPr>
        <p:cNvPr id="68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2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0" name="Google Shape;70;p12"/>
          <p:cNvSpPr txBox="1"/>
          <p:nvPr>
            <p:ph idx="1" type="body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1" name="Google Shape;71;p12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2" name="Google Shape;72;p12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3" name="Google Shape;73;p12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Vertical Title and Text" type="vertTitleAndTx">
  <p:cSld name="VERTICAL_TITLE_AND_VERTICAL_TEXT">
    <p:spTree>
      <p:nvGrpSpPr>
        <p:cNvPr id="74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3"/>
          <p:cNvSpPr txBox="1"/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6" name="Google Shape;76;p13"/>
          <p:cNvSpPr txBox="1"/>
          <p:nvPr>
            <p:ph idx="1" type="body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7" name="Google Shape;77;p13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8" name="Google Shape;78;p13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9" name="Google Shape;79;p13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15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4"/>
          <p:cNvSpPr txBox="1"/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Play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7" name="Google Shape;17;p4"/>
          <p:cNvSpPr txBox="1"/>
          <p:nvPr>
            <p:ph idx="1" type="subTitle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/>
        </p:txBody>
      </p:sp>
      <p:sp>
        <p:nvSpPr>
          <p:cNvPr id="18" name="Google Shape;18;p4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9" name="Google Shape;19;p4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0" name="Google Shape;20;p4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Content" type="obj">
  <p:cSld name="OBJECT">
    <p:spTree>
      <p:nvGrpSpPr>
        <p:cNvPr id="2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5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3" name="Google Shape;23;p5"/>
          <p:cNvSpPr txBox="1"/>
          <p:nvPr>
            <p:ph idx="1" type="body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24" name="Google Shape;24;p5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5" name="Google Shape;25;p5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6" name="Google Shape;26;p5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27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6"/>
          <p:cNvSpPr txBox="1"/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Play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9" name="Google Shape;29;p6"/>
          <p:cNvSpPr txBox="1"/>
          <p:nvPr>
            <p:ph idx="1" type="body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757575"/>
              </a:buClr>
              <a:buSzPts val="2400"/>
              <a:buNone/>
              <a:defRPr sz="2400">
                <a:solidFill>
                  <a:srgbClr val="757575"/>
                </a:solidFill>
              </a:defRPr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2000"/>
              <a:buNone/>
              <a:defRPr sz="2000">
                <a:solidFill>
                  <a:srgbClr val="757575"/>
                </a:solidFill>
              </a:defRPr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800"/>
              <a:buNone/>
              <a:defRPr sz="1800">
                <a:solidFill>
                  <a:srgbClr val="757575"/>
                </a:solidFill>
              </a:defRPr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9pPr>
          </a:lstStyle>
          <a:p/>
        </p:txBody>
      </p:sp>
      <p:sp>
        <p:nvSpPr>
          <p:cNvPr id="30" name="Google Shape;30;p6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1" name="Google Shape;31;p6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2" name="Google Shape;32;p6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wo Content" type="twoObj">
  <p:cSld name="TWO_OBJECTS">
    <p:spTree>
      <p:nvGrpSpPr>
        <p:cNvPr id="33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7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5" name="Google Shape;35;p7"/>
          <p:cNvSpPr txBox="1"/>
          <p:nvPr>
            <p:ph idx="1" type="body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6" name="Google Shape;36;p7"/>
          <p:cNvSpPr txBox="1"/>
          <p:nvPr>
            <p:ph idx="2" type="body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7" name="Google Shape;37;p7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8" name="Google Shape;38;p7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9" name="Google Shape;39;p7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mparison" type="twoTxTwoObj">
  <p:cSld name="TWO_OBJECTS_WITH_TEXT">
    <p:spTree>
      <p:nvGrpSpPr>
        <p:cNvPr id="40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8"/>
          <p:cNvSpPr txBox="1"/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2" name="Google Shape;42;p8"/>
          <p:cNvSpPr txBox="1"/>
          <p:nvPr>
            <p:ph idx="1" type="body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43" name="Google Shape;43;p8"/>
          <p:cNvSpPr txBox="1"/>
          <p:nvPr>
            <p:ph idx="2" type="body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4" name="Google Shape;44;p8"/>
          <p:cNvSpPr txBox="1"/>
          <p:nvPr>
            <p:ph idx="3" type="body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45" name="Google Shape;45;p8"/>
          <p:cNvSpPr txBox="1"/>
          <p:nvPr>
            <p:ph idx="4" type="body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6" name="Google Shape;46;p8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7" name="Google Shape;47;p8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8" name="Google Shape;48;p8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49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9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1" name="Google Shape;51;p9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2" name="Google Shape;52;p9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3" name="Google Shape;53;p9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ntent with Caption" type="objTx">
  <p:cSld name="OBJECT_WITH_CAPTION_TEXT">
    <p:spTree>
      <p:nvGrpSpPr>
        <p:cNvPr id="54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0"/>
          <p:cNvSpPr txBox="1"/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Play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6" name="Google Shape;56;p10"/>
          <p:cNvSpPr txBox="1"/>
          <p:nvPr>
            <p:ph idx="1" type="body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318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indent="-4064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indent="-3810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indent="-355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indent="-355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indent="-355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indent="-355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indent="-355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indent="-355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/>
        </p:txBody>
      </p:sp>
      <p:sp>
        <p:nvSpPr>
          <p:cNvPr id="57" name="Google Shape;57;p10"/>
          <p:cNvSpPr txBox="1"/>
          <p:nvPr>
            <p:ph idx="2" type="body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/>
        </p:txBody>
      </p:sp>
      <p:sp>
        <p:nvSpPr>
          <p:cNvPr id="58" name="Google Shape;58;p10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9" name="Google Shape;59;p10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0" name="Google Shape;60;p10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Picture with Caption" type="picTx">
  <p:cSld name="PICTURE_WITH_CAPTION_TEXT">
    <p:spTree>
      <p:nvGrpSpPr>
        <p:cNvPr id="6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1"/>
          <p:cNvSpPr txBox="1"/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Play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3" name="Google Shape;63;p11"/>
          <p:cNvSpPr/>
          <p:nvPr>
            <p:ph idx="2" type="pic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1"/>
          <p:cNvSpPr txBox="1"/>
          <p:nvPr>
            <p:ph idx="1" type="body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/>
        </p:txBody>
      </p:sp>
      <p:sp>
        <p:nvSpPr>
          <p:cNvPr id="65" name="Google Shape;65;p11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6" name="Google Shape;66;p11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7" name="Google Shape;67;p11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1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2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marR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Play"/>
              <a:buNone/>
              <a:defRPr b="0" i="0" sz="4400" u="none" cap="none" strike="noStrike">
                <a:solidFill>
                  <a:schemeClr val="dk1"/>
                </a:solidFill>
                <a:latin typeface="Play"/>
                <a:ea typeface="Play"/>
                <a:cs typeface="Play"/>
                <a:sym typeface="Play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/>
        </p:txBody>
      </p:sp>
      <p:sp>
        <p:nvSpPr>
          <p:cNvPr id="7" name="Google Shape;7;p2"/>
          <p:cNvSpPr txBox="1"/>
          <p:nvPr>
            <p:ph idx="1" type="body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06400" lvl="0" marL="457200" marR="0" rtl="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b="0" i="0" sz="2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-381000" lvl="1" marL="9144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b="0" i="0" sz="24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-355600" lvl="2" marL="13716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b="0" i="0" sz="2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-342900" lvl="3" marL="18288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-342900" lvl="4" marL="22860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-342900" lvl="5" marL="27432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-342900" lvl="6" marL="32004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-342900" lvl="7" marL="36576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-342900" lvl="8" marL="41148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/>
        </p:txBody>
      </p:sp>
      <p:sp>
        <p:nvSpPr>
          <p:cNvPr id="8" name="Google Shape;8;p2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/>
        </p:txBody>
      </p:sp>
      <p:sp>
        <p:nvSpPr>
          <p:cNvPr id="9" name="Google Shape;9;p2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ctr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/>
        </p:txBody>
      </p:sp>
      <p:sp>
        <p:nvSpPr>
          <p:cNvPr id="10" name="Google Shape;10;p2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0" lvl="1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0" lvl="2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0" lvl="3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0" lvl="4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0" lvl="5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0" lvl="6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0" lvl="7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0" lvl="8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IN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jp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3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1"/>
          <p:cNvSpPr txBox="1"/>
          <p:nvPr/>
        </p:nvSpPr>
        <p:spPr>
          <a:xfrm>
            <a:off x="704849" y="5546289"/>
            <a:ext cx="11020500" cy="6465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IN" sz="1200" u="none" cap="none" strike="noStrik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upplementary Figure S</a:t>
            </a:r>
            <a:r>
              <a:rPr b="1" lang="en-IN" sz="12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7</a:t>
            </a:r>
            <a:r>
              <a:rPr b="1" i="0" lang="en-IN" sz="1200" u="none" cap="none" strike="noStrike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: </a:t>
            </a:r>
            <a:r>
              <a:rPr lang="en-IN" sz="12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Comparative synteny among </a:t>
            </a:r>
            <a:r>
              <a:rPr i="1" lang="en-IN" sz="12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P. tetragonolobus</a:t>
            </a:r>
            <a:r>
              <a:rPr lang="en-IN" sz="12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, </a:t>
            </a:r>
            <a:r>
              <a:rPr i="1" lang="en-IN" sz="12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Vigna radiata</a:t>
            </a:r>
            <a:r>
              <a:rPr lang="en-IN" sz="12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, and </a:t>
            </a:r>
            <a:r>
              <a:rPr i="1" lang="en-IN" sz="12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Medicago truncatula</a:t>
            </a:r>
            <a:r>
              <a:rPr lang="en-IN" sz="12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, illustrating more fragmented and subtelomerically localized conserved blocks, indicative of higher genomic divergence.</a:t>
            </a:r>
            <a:endParaRPr sz="1200">
              <a:solidFill>
                <a:schemeClr val="dk1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200">
              <a:solidFill>
                <a:schemeClr val="dk1"/>
              </a:solidFill>
              <a:latin typeface="Times New Roman"/>
              <a:ea typeface="Times New Roman"/>
              <a:cs typeface="Times New Roman"/>
              <a:sym typeface="Times New Roman"/>
            </a:endParaRPr>
          </a:p>
        </p:txBody>
      </p:sp>
      <p:pic>
        <p:nvPicPr>
          <p:cNvPr id="85" name="Google Shape;85;p1" title="vigna_and_medicago.jpg"/>
          <p:cNvPicPr preferRelativeResize="0"/>
          <p:nvPr/>
        </p:nvPicPr>
        <p:blipFill rotWithShape="1">
          <a:blip r:embed="rId3">
            <a:alphaModFix/>
          </a:blip>
          <a:srcRect b="39650" l="0" r="0" t="5048"/>
          <a:stretch/>
        </p:blipFill>
        <p:spPr>
          <a:xfrm>
            <a:off x="152400" y="648875"/>
            <a:ext cx="11904476" cy="44055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 name="Office Theme">
  <a:themeElements>
    <a:clrScheme name="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5-07-01T07:08:29Z</dcterms:created>
  <dc:creator>Kishor Tribhuvan</dc:creator>
</cp:coreProperties>
</file>